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3" d="100"/>
          <a:sy n="73" d="100"/>
        </p:scale>
        <p:origin x="72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ED042C-F54B-44D4-B534-7161FB6671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D6AE89-5650-4885-AAED-A38F796AB1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73A4A1-ABB6-4478-A80A-913F63421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4E01F5-B85E-476C-85D4-8F4C43052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A5387-FEEB-42A9-8061-9D6F77C8F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540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5361F-EC61-4310-9704-1B6FBA217B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46E9B4-E120-4160-9013-7D688844A1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DB8752-B9AC-4981-AA2B-3E2B7ADFE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5E0102-A0E8-4460-9705-CFE278F7F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3910F3-8992-4EFF-AEC9-ECA254DF1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555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9E40D6-2900-4EED-BDD5-11F6C3F7A8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E76D6E-820C-43A7-B715-8808B42C8F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CE1BA6-3CFB-4385-8C40-E47550866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1C5FF7-CE14-419C-864B-1F6B1B43B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2757D2-7367-47F1-955E-ADADFA7430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361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4CFBAC-2B49-4E7C-91F1-AA3A144B2E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35A408-4D07-4A34-B316-ADFD942B37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07F79A-BFDE-4CD6-A2C6-9EEAA1B83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481E34-4E6B-43FB-81EF-0F6D8756A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D6993A-E94F-471E-A368-162D17F03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525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275AB8-5EC1-48A5-BCF8-CD7B651814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7E56EC-6EE5-4322-863F-05E147D75B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5EFE68-F5BA-452B-8EA7-201C08617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8D8C8-B77E-4037-BA1E-C28A406CB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E5397B-A848-48A0-A499-4E21A04D0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510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F81659-360B-4511-AE49-8C4DE9BC0C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70D3DD-1B59-4F5D-9DE2-A8AAEF510C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5D784E-E54E-4B99-AEAB-2AA2481207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419BCD-C2A1-4057-9ED4-CBA6E1680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1F4A4B-D832-431E-9307-16AB0990F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C35826-C3B7-4006-A5E0-F03F558EE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755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94D7A4-CBF9-48E1-836F-FA07D346FC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58EA2B-922C-442D-BAD2-0DA947A3DD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B9DB89-1137-4E0B-B579-28397C511C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FF5057-A0B6-4CD7-ABED-251979BF7B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576E64-B1C6-4334-8A78-77F238B5FF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31AF73D-83B6-40CB-9D93-E4E057DDC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6DBD331-3AC6-4E87-B0E4-430BE2366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777BC8-D4A7-4848-BCF3-58DBC0FF8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433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3CD20-251D-4804-B032-933C3884E6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C6AD90-DCD0-4405-B44C-6644F730E9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84165C0-F2C6-4039-BD88-58257A376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39C6E5-D54B-4A2F-8602-2A8C680FB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924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0CE208-2ADA-4260-846D-7031EA05A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31E7D86-6ED8-40F9-8711-21F3E777B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66F599-5EB3-40A9-8C3C-0B8CC797C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369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72D224-E1A9-4942-9E38-08287BDF09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4FBA6E-FB90-4100-B485-5B95996682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C66206-F152-4677-A271-0BBA63F486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2F6E7D-B852-4625-95B7-DE5A4D8FB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237DE8-0B45-4D92-BA18-B498651F1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0B9D42-FF04-4194-8FEA-694E6B285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452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775A2-0F83-4987-94EC-12B41A725C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2CA09E-AC1E-4B76-8347-5DC306485B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E1FBFE-86E6-416E-86A4-22BC1B0255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56502D-A9C3-4B43-A636-EEA3472C8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3540C5-D562-4F8C-9947-40B61E730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DC0AE4-0C92-4F34-831F-8F6F57D1C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265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835C8D-3552-4657-9E35-DBF336246C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C5D333-B7B5-4B17-8DCE-6193EED8BD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D82846-58F5-4199-B527-07DFDA8FBE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928E2E-A393-455C-90F9-BC08DE9E691E}" type="datetimeFigureOut">
              <a:rPr lang="en-US" smtClean="0"/>
              <a:t>10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B95190-232E-4B62-9881-BA676C0385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F7A04D-889C-48B0-A83B-DCF9308E72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A9CEA-90A8-4297-A367-D7562EE4F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899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F4F477F-B0DD-4BF3-A034-9058605D4C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5247" y="472059"/>
            <a:ext cx="4539423" cy="259395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767B976-42CF-41B7-B312-849CD67CEF5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11" t="11143" r="15190" b="6617"/>
          <a:stretch/>
        </p:blipFill>
        <p:spPr>
          <a:xfrm>
            <a:off x="6463913" y="475815"/>
            <a:ext cx="4714801" cy="259395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1DC74CC-8A9C-48D4-A9F5-097213740A4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157" t="9332" r="13900" b="6100"/>
          <a:stretch/>
        </p:blipFill>
        <p:spPr>
          <a:xfrm>
            <a:off x="735247" y="4000992"/>
            <a:ext cx="4592967" cy="259395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D252664-35CE-4247-BB01-A4D19F2674D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733" r="13189"/>
          <a:stretch/>
        </p:blipFill>
        <p:spPr>
          <a:xfrm>
            <a:off x="6463912" y="3892730"/>
            <a:ext cx="4929913" cy="296526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EE9B189-5D21-4096-9DC6-75671337EADF}"/>
              </a:ext>
            </a:extLst>
          </p:cNvPr>
          <p:cNvSpPr txBox="1"/>
          <p:nvPr/>
        </p:nvSpPr>
        <p:spPr>
          <a:xfrm>
            <a:off x="1013286" y="263053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icea </a:t>
            </a:r>
            <a:r>
              <a:rPr lang="de-DE" dirty="0" err="1"/>
              <a:t>abies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9A3F952-9BC2-4E1B-ACDD-8147E69F740A}"/>
              </a:ext>
            </a:extLst>
          </p:cNvPr>
          <p:cNvSpPr txBox="1"/>
          <p:nvPr/>
        </p:nvSpPr>
        <p:spPr>
          <a:xfrm>
            <a:off x="6776571" y="263053"/>
            <a:ext cx="15895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inus s</a:t>
            </a:r>
            <a:r>
              <a:rPr lang="et-EE" dirty="0"/>
              <a:t>y</a:t>
            </a:r>
            <a:r>
              <a:rPr lang="de-DE" dirty="0" err="1"/>
              <a:t>lvestris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10AB5C-A1F4-4C13-BC5D-5BF37A0F9286}"/>
              </a:ext>
            </a:extLst>
          </p:cNvPr>
          <p:cNvSpPr txBox="1"/>
          <p:nvPr/>
        </p:nvSpPr>
        <p:spPr>
          <a:xfrm>
            <a:off x="1064466" y="3816326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 err="1"/>
              <a:t>Abies</a:t>
            </a:r>
            <a:r>
              <a:rPr lang="et-EE" dirty="0"/>
              <a:t> </a:t>
            </a:r>
            <a:r>
              <a:rPr lang="et-EE" dirty="0" err="1"/>
              <a:t>alba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AB848F8-97A8-49C6-90AE-FC5AD4FFF85E}"/>
              </a:ext>
            </a:extLst>
          </p:cNvPr>
          <p:cNvSpPr txBox="1"/>
          <p:nvPr/>
        </p:nvSpPr>
        <p:spPr>
          <a:xfrm>
            <a:off x="7051074" y="3816326"/>
            <a:ext cx="1420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 err="1"/>
              <a:t>Larix</a:t>
            </a:r>
            <a:r>
              <a:rPr lang="et-EE" dirty="0"/>
              <a:t> </a:t>
            </a:r>
            <a:r>
              <a:rPr lang="et-EE" dirty="0" err="1"/>
              <a:t>decidu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05861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EB9915B-2C54-4CDF-A287-02F9E099EC0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143" r="12754" b="5324"/>
          <a:stretch/>
        </p:blipFill>
        <p:spPr>
          <a:xfrm>
            <a:off x="504172" y="565791"/>
            <a:ext cx="5066222" cy="268685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71D1E19-959F-4477-A82D-E6CC32106EA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0625" r="14187" b="5065"/>
          <a:stretch/>
        </p:blipFill>
        <p:spPr>
          <a:xfrm>
            <a:off x="6264449" y="548145"/>
            <a:ext cx="4969608" cy="270450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093C38A-EC8C-403F-B62B-59AA90C7FAC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644" t="9231" r="12975" b="4473"/>
          <a:stretch/>
        </p:blipFill>
        <p:spPr>
          <a:xfrm>
            <a:off x="699637" y="3879669"/>
            <a:ext cx="4934650" cy="279545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33A6921-5ED7-4EEB-A74A-19FBDC42D13E}"/>
              </a:ext>
            </a:extLst>
          </p:cNvPr>
          <p:cNvSpPr txBox="1"/>
          <p:nvPr/>
        </p:nvSpPr>
        <p:spPr>
          <a:xfrm>
            <a:off x="957943" y="363479"/>
            <a:ext cx="149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 err="1"/>
              <a:t>Quercus</a:t>
            </a:r>
            <a:r>
              <a:rPr lang="et-EE" dirty="0"/>
              <a:t> </a:t>
            </a:r>
            <a:r>
              <a:rPr lang="et-EE" dirty="0" err="1"/>
              <a:t>spec</a:t>
            </a:r>
            <a:r>
              <a:rPr lang="et-EE" dirty="0"/>
              <a:t>.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418A780-0625-428D-9F25-24805F6B78A0}"/>
              </a:ext>
            </a:extLst>
          </p:cNvPr>
          <p:cNvSpPr txBox="1"/>
          <p:nvPr/>
        </p:nvSpPr>
        <p:spPr>
          <a:xfrm>
            <a:off x="6724711" y="349922"/>
            <a:ext cx="1614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 err="1"/>
              <a:t>Fagus</a:t>
            </a:r>
            <a:r>
              <a:rPr lang="et-EE" dirty="0"/>
              <a:t> </a:t>
            </a:r>
            <a:r>
              <a:rPr lang="et-EE" dirty="0" err="1"/>
              <a:t>sylvatica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17A3EB5-17DE-4CCC-B9DC-B6BE40EF12E4}"/>
              </a:ext>
            </a:extLst>
          </p:cNvPr>
          <p:cNvSpPr txBox="1"/>
          <p:nvPr/>
        </p:nvSpPr>
        <p:spPr>
          <a:xfrm>
            <a:off x="1084217" y="3695003"/>
            <a:ext cx="1932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 err="1"/>
              <a:t>Minor</a:t>
            </a:r>
            <a:r>
              <a:rPr lang="et-EE" dirty="0"/>
              <a:t> </a:t>
            </a:r>
            <a:r>
              <a:rPr lang="et-EE" dirty="0" err="1"/>
              <a:t>tree</a:t>
            </a:r>
            <a:r>
              <a:rPr lang="et-EE" dirty="0"/>
              <a:t> </a:t>
            </a:r>
            <a:r>
              <a:rPr lang="et-EE" dirty="0" err="1"/>
              <a:t>speci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3840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</Words>
  <Application>Microsoft Office PowerPoint</Application>
  <PresentationFormat>Widescreen</PresentationFormat>
  <Paragraphs>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 Peter George</dc:creator>
  <cp:lastModifiedBy>Jan Peter George</cp:lastModifiedBy>
  <cp:revision>2</cp:revision>
  <dcterms:created xsi:type="dcterms:W3CDTF">2021-10-28T08:03:35Z</dcterms:created>
  <dcterms:modified xsi:type="dcterms:W3CDTF">2021-10-28T08:05:10Z</dcterms:modified>
</cp:coreProperties>
</file>